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65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3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F6F8D3-C54C-2E47-8D02-9C09B977D43E}" type="datetimeFigureOut">
              <a:rPr lang="en-US" smtClean="0"/>
              <a:t>12/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494B44-4954-A148-BE5B-045466FF6F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913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endParaRPr lang="en-US" sz="1800" b="0" i="0" u="none" strike="noStrike" baseline="0" dirty="0">
              <a:latin typeface="Garamond" panose="02020404030301010803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D8FD4326-7D0D-4848-886C-330CA99CB467}" type="slidenum">
              <a:rPr kumimoji="0" lang="en-GB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GB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028831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147DF8-60CE-784F-B00A-BED9ACF7FE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C617E68-F210-FC40-8E53-DCC55D103AB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E47481-2301-9046-B606-C32D27862A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88C011-BB2E-6742-A52E-C4FC310F0C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5E90E7-EF5E-DF4E-A5A8-8D74351BB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8152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7B7372-6404-E146-8937-B1C71FB821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B2930C-1268-EE44-B98A-B120BB4BEE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29D6B3-BBEA-C643-BE0A-98D48EA6D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C8A191-737F-1F41-9D2A-C96AC2CC1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A7C62C-6F0B-9F4D-BE87-86821CD360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3373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7E722EE-2ED5-D346-BACD-83E9E7F280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240A6B-C042-C444-B4DC-F0C1B3DF5D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1EC5BB-268B-2C4D-B77D-F22F98028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3374EB-C66A-9C4F-B1BF-4A083DFFEF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7BC634-E9DA-1846-AFF7-C2420ED0D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9249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CDED97-CB98-7241-9677-855ED44418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7DD3B1-72EE-3C4E-A616-7586577188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530024-E659-854A-A354-175C39B2C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1520FF-C0D2-1145-B5D2-423A2560A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56292C-714A-134F-81B1-3037FE557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8644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FDB117-3FA7-3C44-A3C5-136D09555F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AC98C7-A3E5-364F-8DF5-A8B51486BA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C079D3-F2B7-EC4A-8D7A-04AD74D079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4C96C7-9CBD-404A-B42C-6D720E78C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D4D2E8-1C72-554E-A3B8-34A55FE0E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4934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654DA-3D55-C84B-9614-2876C8B4B9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46781E-178C-BD49-9857-A2EDBDF27A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34CD5A-2ED6-3147-9661-37BDEACB0C9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682111-52AC-6A40-86C5-8F4D78B17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E2AB4D-80D5-FC4D-84F6-1E0C220ED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0A2AE4-6708-5348-939C-8B07CF1A6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4675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8FA874-5C92-024E-9E19-1A7AEEE90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D7D3FE-EE6B-CE4A-BE1A-53F498794D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65020E-C953-9247-AD5E-EA2993460E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E69673D-6B10-8A4C-9B54-E46018F31B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14C5291-E3C3-0542-8998-6D7948C6A2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A57313-6B63-714B-AE00-479DD23E53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6BC259-3773-594A-9D5F-5F31696C9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6B03F3D-677C-EE49-A7B2-7AB29FD83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100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F8507F-EB1A-4A4D-8C84-2FA251DA0E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233BAD0-B5CD-9F43-99C0-7223307EB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8CA39F-1CCE-8344-9532-E45BFDB225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9376D8-D8DB-9F45-961A-171D8FAD7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360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C826136-1DEE-3941-853A-7A445F4444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575CC5E-8402-084F-AFFE-9BCA3D0FA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DD03054-D117-A349-8DB8-5A3984E8E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3807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330D14-2A6C-D04C-B60F-367894DF06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EA46EB-8860-4349-82B4-885B301963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14532C-71AA-B143-AA6D-1E5AB8B492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B4211A-4285-EC4E-8D8D-8F624548F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22FFA3-54E8-6344-A59E-08B8EBAB2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675AF4-DC0F-C248-9F5E-94F10EBFC3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84564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3DF917-6576-DB44-8C42-D28040D6C2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FB97BDD-2458-2E41-BBC3-51C21CFF9E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388A446-B5B8-2548-AC24-AE60A15123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752FB5-EEC8-1842-BE45-0844CBBB2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CB7386-4DE2-DD43-BA65-F9DCC4BC3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001846B-D394-934A-8843-7E25FBD42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0645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43F996-538C-A44F-80C9-F93581362E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369089-7110-D543-91DF-FBE3572C08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2C795F-4B29-2E4D-B8DF-5273257B00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685C60-1392-AE44-9F42-A83283FACD1C}" type="datetimeFigureOut">
              <a:rPr lang="en-GB" smtClean="0"/>
              <a:t>07/12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7A96DA-5228-3846-8851-BC105C454D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0DA099-8041-0C4A-B2C4-6E34F4F357C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60713B-2FE7-0243-B456-4C568F5E39D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624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14EEDA53-3799-436A-A804-32699CFBA45A}"/>
              </a:ext>
            </a:extLst>
          </p:cNvPr>
          <p:cNvSpPr txBox="1"/>
          <p:nvPr/>
        </p:nvSpPr>
        <p:spPr>
          <a:xfrm>
            <a:off x="5077156" y="399453"/>
            <a:ext cx="255072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aramond" panose="02020404030301010803" pitchFamily="18" charset="0"/>
                <a:ea typeface="+mn-ea"/>
                <a:cs typeface="+mn-cs"/>
              </a:rPr>
              <a:t>AAV-Cited2-GFP</a:t>
            </a:r>
            <a:endParaRPr kumimoji="0" lang="en-US" sz="20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Garamond" panose="02020404030301010803" pitchFamily="18" charset="0"/>
              <a:ea typeface="+mn-ea"/>
              <a:cs typeface="+mn-cs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D2FB0C41-2249-498E-A97F-0DC0DD29C931}"/>
              </a:ext>
            </a:extLst>
          </p:cNvPr>
          <p:cNvGrpSpPr/>
          <p:nvPr/>
        </p:nvGrpSpPr>
        <p:grpSpPr>
          <a:xfrm>
            <a:off x="6152059" y="813121"/>
            <a:ext cx="2353076" cy="4740108"/>
            <a:chOff x="2034013" y="1037421"/>
            <a:chExt cx="2353076" cy="4740108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D14B6C3-50CE-4F4A-B338-AF751EE4EA68}"/>
                </a:ext>
              </a:extLst>
            </p:cNvPr>
            <p:cNvSpPr txBox="1"/>
            <p:nvPr/>
          </p:nvSpPr>
          <p:spPr>
            <a:xfrm>
              <a:off x="2035818" y="3499072"/>
              <a:ext cx="1474016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l-GR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β</a:t>
              </a:r>
              <a:r>
                <a: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aramond" panose="02020404030301010803" pitchFamily="18" charset="0"/>
                  <a:ea typeface="+mn-ea"/>
                  <a:cs typeface="Arial" panose="020B0604020202020204" pitchFamily="34" charset="0"/>
                </a:rPr>
                <a:t>III</a:t>
              </a:r>
              <a:r>
                <a:rPr kumimoji="0" lang="en-US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Garamond" panose="02020404030301010803" pitchFamily="18" charset="0"/>
                  <a:ea typeface="+mn-ea"/>
                  <a:cs typeface="+mn-cs"/>
                </a:rPr>
                <a:t>-TUB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ECA3250D-2CAE-48BB-8E9D-B02A26380BA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840497" y="2230937"/>
              <a:ext cx="4740108" cy="2353076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</p:grp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4C7D57E3-7E60-4E3B-94B4-0ADF85369EF3}"/>
              </a:ext>
            </a:extLst>
          </p:cNvPr>
          <p:cNvCxnSpPr>
            <a:cxnSpLocks/>
          </p:cNvCxnSpPr>
          <p:nvPr/>
        </p:nvCxnSpPr>
        <p:spPr>
          <a:xfrm>
            <a:off x="6152059" y="5637736"/>
            <a:ext cx="2357664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D20C8C44-D481-48C8-B382-662546A8AF63}"/>
              </a:ext>
            </a:extLst>
          </p:cNvPr>
          <p:cNvSpPr txBox="1"/>
          <p:nvPr/>
        </p:nvSpPr>
        <p:spPr>
          <a:xfrm>
            <a:off x="6213533" y="5633229"/>
            <a:ext cx="235766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aramond" panose="02020404030301010803" pitchFamily="18" charset="0"/>
                <a:ea typeface="+mn-ea"/>
                <a:cs typeface="Arial" panose="020B0604020202020204" pitchFamily="34" charset="0"/>
              </a:rPr>
              <a:t>Multipolar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Garamond" panose="02020404030301010803" pitchFamily="18" charset="0"/>
              <a:ea typeface="+mn-ea"/>
              <a:cs typeface="+mn-cs"/>
            </a:endParaRPr>
          </a:p>
        </p:txBody>
      </p:sp>
      <p:pic>
        <p:nvPicPr>
          <p:cNvPr id="21" name="Picture 20" descr="A picture containing dark, night sky&#10;&#10;Description automatically generated">
            <a:extLst>
              <a:ext uri="{FF2B5EF4-FFF2-40B4-BE49-F238E27FC236}">
                <a16:creationId xmlns:a16="http://schemas.microsoft.com/office/drawing/2014/main" id="{A2448903-FF9D-402E-A476-54BC7613AE0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-151629" y="1993388"/>
            <a:ext cx="4741334" cy="2353684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3C537040-AE8A-4B18-9402-CBA6864BDEA1}"/>
              </a:ext>
            </a:extLst>
          </p:cNvPr>
          <p:cNvSpPr txBox="1"/>
          <p:nvPr/>
        </p:nvSpPr>
        <p:spPr>
          <a:xfrm>
            <a:off x="967723" y="5633230"/>
            <a:ext cx="236668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aramond" panose="02020404030301010803" pitchFamily="18" charset="0"/>
                <a:ea typeface="+mn-ea"/>
                <a:cs typeface="Arial" panose="020B0604020202020204" pitchFamily="34" charset="0"/>
              </a:rPr>
              <a:t>Pseudo-unipolar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Garamond" panose="02020404030301010803" pitchFamily="18" charset="0"/>
              <a:ea typeface="+mn-ea"/>
              <a:cs typeface="+mn-cs"/>
            </a:endParaRP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086C3E7-4711-42C2-A94F-18A58B7A231A}"/>
              </a:ext>
            </a:extLst>
          </p:cNvPr>
          <p:cNvCxnSpPr>
            <a:cxnSpLocks/>
          </p:cNvCxnSpPr>
          <p:nvPr/>
        </p:nvCxnSpPr>
        <p:spPr>
          <a:xfrm>
            <a:off x="1042196" y="5641789"/>
            <a:ext cx="2353684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14EEDA53-3799-436A-A804-32699CFBA45A}"/>
              </a:ext>
            </a:extLst>
          </p:cNvPr>
          <p:cNvSpPr txBox="1"/>
          <p:nvPr/>
        </p:nvSpPr>
        <p:spPr>
          <a:xfrm>
            <a:off x="1528633" y="399453"/>
            <a:ext cx="138080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aramond" panose="02020404030301010803" pitchFamily="18" charset="0"/>
                <a:ea typeface="+mn-ea"/>
                <a:cs typeface="+mn-cs"/>
              </a:rPr>
              <a:t>AAV-GFP</a:t>
            </a:r>
            <a:endParaRPr kumimoji="0" lang="en-US" sz="20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Garamond" panose="02020404030301010803" pitchFamily="18" charset="0"/>
              <a:ea typeface="+mn-ea"/>
              <a:cs typeface="+mn-cs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AC2A758-6F25-4A96-984D-DC4E699742FF}"/>
              </a:ext>
            </a:extLst>
          </p:cNvPr>
          <p:cNvSpPr txBox="1"/>
          <p:nvPr/>
        </p:nvSpPr>
        <p:spPr>
          <a:xfrm rot="16200000">
            <a:off x="267196" y="1731981"/>
            <a:ext cx="1191858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aramond" panose="02020404030301010803" pitchFamily="18" charset="0"/>
                <a:ea typeface="+mn-ea"/>
                <a:cs typeface="Arial" panose="020B0604020202020204" pitchFamily="34" charset="0"/>
              </a:rPr>
              <a:t>Cited2-GFP</a:t>
            </a:r>
            <a:endParaRPr kumimoji="0" lang="en-US" sz="11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Garamond" panose="02020404030301010803" pitchFamily="18" charset="0"/>
              <a:ea typeface="+mn-ea"/>
              <a:cs typeface="+mn-cs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D14B6C3-50CE-4F4A-B338-AF751EE4EA68}"/>
              </a:ext>
            </a:extLst>
          </p:cNvPr>
          <p:cNvSpPr txBox="1"/>
          <p:nvPr/>
        </p:nvSpPr>
        <p:spPr>
          <a:xfrm rot="16200000">
            <a:off x="126117" y="3892690"/>
            <a:ext cx="147401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l-GR" sz="11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β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aramond" panose="02020404030301010803" pitchFamily="18" charset="0"/>
                <a:ea typeface="+mn-ea"/>
                <a:cs typeface="Arial" panose="020B0604020202020204" pitchFamily="34" charset="0"/>
              </a:rPr>
              <a:t>III</a:t>
            </a:r>
            <a:r>
              <a:rPr kumimoji="0" 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aramond" panose="02020404030301010803" pitchFamily="18" charset="0"/>
                <a:ea typeface="+mn-ea"/>
                <a:cs typeface="+mn-cs"/>
              </a:rPr>
              <a:t>-TUB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666C61AC-7429-4C86-AF4E-5BEF92E529D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 rot="5400000">
            <a:off x="2483767" y="2006625"/>
            <a:ext cx="4740109" cy="2353101"/>
          </a:xfrm>
          <a:prstGeom prst="rect">
            <a:avLst/>
          </a:prstGeom>
          <a:ln>
            <a:solidFill>
              <a:schemeClr val="bg1"/>
            </a:solidFill>
          </a:ln>
        </p:spPr>
      </p:pic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B086C3E7-4711-42C2-A94F-18A58B7A231A}"/>
              </a:ext>
            </a:extLst>
          </p:cNvPr>
          <p:cNvCxnSpPr>
            <a:cxnSpLocks/>
          </p:cNvCxnSpPr>
          <p:nvPr/>
        </p:nvCxnSpPr>
        <p:spPr>
          <a:xfrm>
            <a:off x="3677271" y="5641789"/>
            <a:ext cx="2353684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D20C8C44-D481-48C8-B382-662546A8AF63}"/>
              </a:ext>
            </a:extLst>
          </p:cNvPr>
          <p:cNvSpPr txBox="1"/>
          <p:nvPr/>
        </p:nvSpPr>
        <p:spPr>
          <a:xfrm>
            <a:off x="3674988" y="5641789"/>
            <a:ext cx="235766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Garamond" panose="02020404030301010803" pitchFamily="18" charset="0"/>
                <a:ea typeface="+mn-ea"/>
                <a:cs typeface="Arial" panose="020B0604020202020204" pitchFamily="34" charset="0"/>
              </a:rPr>
              <a:t>Non-differentiated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Garamond" panose="02020404030301010803" pitchFamily="18" charset="0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90390183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1</Words>
  <Application>Microsoft Macintosh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Garamond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ranziska Mueller</dc:creator>
  <cp:lastModifiedBy>Franziska Mueller</cp:lastModifiedBy>
  <cp:revision>1</cp:revision>
  <dcterms:created xsi:type="dcterms:W3CDTF">2025-12-07T18:15:16Z</dcterms:created>
  <dcterms:modified xsi:type="dcterms:W3CDTF">2025-12-07T18:17:21Z</dcterms:modified>
</cp:coreProperties>
</file>